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20" r:id="rId1"/>
  </p:sldMasterIdLst>
  <p:sldIdLst>
    <p:sldId id="274" r:id="rId2"/>
  </p:sldIdLst>
  <p:sldSz cx="11880850" cy="14400213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39" d="100"/>
          <a:sy n="39" d="100"/>
        </p:scale>
        <p:origin x="2347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91064" y="2356703"/>
            <a:ext cx="10098723" cy="5013407"/>
          </a:xfrm>
        </p:spPr>
        <p:txBody>
          <a:bodyPr anchor="b"/>
          <a:lstStyle>
            <a:lvl1pPr algn="ctr">
              <a:defRPr sz="779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106" y="7563446"/>
            <a:ext cx="8910638" cy="3476717"/>
          </a:xfrm>
        </p:spPr>
        <p:txBody>
          <a:bodyPr/>
          <a:lstStyle>
            <a:lvl1pPr marL="0" indent="0" algn="ctr">
              <a:buNone/>
              <a:defRPr sz="3118"/>
            </a:lvl1pPr>
            <a:lvl2pPr marL="594040" indent="0" algn="ctr">
              <a:buNone/>
              <a:defRPr sz="2599"/>
            </a:lvl2pPr>
            <a:lvl3pPr marL="1188080" indent="0" algn="ctr">
              <a:buNone/>
              <a:defRPr sz="2339"/>
            </a:lvl3pPr>
            <a:lvl4pPr marL="1782120" indent="0" algn="ctr">
              <a:buNone/>
              <a:defRPr sz="2079"/>
            </a:lvl4pPr>
            <a:lvl5pPr marL="2376160" indent="0" algn="ctr">
              <a:buNone/>
              <a:defRPr sz="2079"/>
            </a:lvl5pPr>
            <a:lvl6pPr marL="2970200" indent="0" algn="ctr">
              <a:buNone/>
              <a:defRPr sz="2079"/>
            </a:lvl6pPr>
            <a:lvl7pPr marL="3564240" indent="0" algn="ctr">
              <a:buNone/>
              <a:defRPr sz="2079"/>
            </a:lvl7pPr>
            <a:lvl8pPr marL="4158280" indent="0" algn="ctr">
              <a:buNone/>
              <a:defRPr sz="2079"/>
            </a:lvl8pPr>
            <a:lvl9pPr marL="4752320" indent="0" algn="ctr">
              <a:buNone/>
              <a:defRPr sz="2079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803B-2CA5-43A1-BEA5-E3B9601A04C9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EC7B-BEB6-4D84-9D7F-A8C5B8692D3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030574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803B-2CA5-43A1-BEA5-E3B9601A04C9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EC7B-BEB6-4D84-9D7F-A8C5B8692D3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61577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02234" y="766678"/>
            <a:ext cx="2561808" cy="1220351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6809" y="766678"/>
            <a:ext cx="7536914" cy="1220351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803B-2CA5-43A1-BEA5-E3B9601A04C9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EC7B-BEB6-4D84-9D7F-A8C5B8692D3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28960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803B-2CA5-43A1-BEA5-E3B9601A04C9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EC7B-BEB6-4D84-9D7F-A8C5B8692D3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199078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0621" y="3590057"/>
            <a:ext cx="10247233" cy="5990088"/>
          </a:xfrm>
        </p:spPr>
        <p:txBody>
          <a:bodyPr anchor="b"/>
          <a:lstStyle>
            <a:lvl1pPr>
              <a:defRPr sz="779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0621" y="9636813"/>
            <a:ext cx="10247233" cy="3150046"/>
          </a:xfrm>
        </p:spPr>
        <p:txBody>
          <a:bodyPr/>
          <a:lstStyle>
            <a:lvl1pPr marL="0" indent="0">
              <a:buNone/>
              <a:defRPr sz="3118">
                <a:solidFill>
                  <a:schemeClr val="tx1"/>
                </a:solidFill>
              </a:defRPr>
            </a:lvl1pPr>
            <a:lvl2pPr marL="594040" indent="0">
              <a:buNone/>
              <a:defRPr sz="2599">
                <a:solidFill>
                  <a:schemeClr val="tx1">
                    <a:tint val="75000"/>
                  </a:schemeClr>
                </a:solidFill>
              </a:defRPr>
            </a:lvl2pPr>
            <a:lvl3pPr marL="1188080" indent="0">
              <a:buNone/>
              <a:defRPr sz="2339">
                <a:solidFill>
                  <a:schemeClr val="tx1">
                    <a:tint val="75000"/>
                  </a:schemeClr>
                </a:solidFill>
              </a:defRPr>
            </a:lvl3pPr>
            <a:lvl4pPr marL="1782120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4pPr>
            <a:lvl5pPr marL="2376160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5pPr>
            <a:lvl6pPr marL="2970200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6pPr>
            <a:lvl7pPr marL="3564240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7pPr>
            <a:lvl8pPr marL="4158280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8pPr>
            <a:lvl9pPr marL="4752320" indent="0">
              <a:buNone/>
              <a:defRPr sz="207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803B-2CA5-43A1-BEA5-E3B9601A04C9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EC7B-BEB6-4D84-9D7F-A8C5B8692D3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075504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6809" y="3833390"/>
            <a:ext cx="5049361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14680" y="3833390"/>
            <a:ext cx="5049361" cy="913680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803B-2CA5-43A1-BEA5-E3B9601A04C9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EC7B-BEB6-4D84-9D7F-A8C5B8692D3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17345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356" y="766681"/>
            <a:ext cx="10247233" cy="278337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8357" y="3530053"/>
            <a:ext cx="5026156" cy="1730025"/>
          </a:xfrm>
        </p:spPr>
        <p:txBody>
          <a:bodyPr anchor="b"/>
          <a:lstStyle>
            <a:lvl1pPr marL="0" indent="0">
              <a:buNone/>
              <a:defRPr sz="3118" b="1"/>
            </a:lvl1pPr>
            <a:lvl2pPr marL="594040" indent="0">
              <a:buNone/>
              <a:defRPr sz="2599" b="1"/>
            </a:lvl2pPr>
            <a:lvl3pPr marL="1188080" indent="0">
              <a:buNone/>
              <a:defRPr sz="2339" b="1"/>
            </a:lvl3pPr>
            <a:lvl4pPr marL="1782120" indent="0">
              <a:buNone/>
              <a:defRPr sz="2079" b="1"/>
            </a:lvl4pPr>
            <a:lvl5pPr marL="2376160" indent="0">
              <a:buNone/>
              <a:defRPr sz="2079" b="1"/>
            </a:lvl5pPr>
            <a:lvl6pPr marL="2970200" indent="0">
              <a:buNone/>
              <a:defRPr sz="2079" b="1"/>
            </a:lvl6pPr>
            <a:lvl7pPr marL="3564240" indent="0">
              <a:buNone/>
              <a:defRPr sz="2079" b="1"/>
            </a:lvl7pPr>
            <a:lvl8pPr marL="4158280" indent="0">
              <a:buNone/>
              <a:defRPr sz="2079" b="1"/>
            </a:lvl8pPr>
            <a:lvl9pPr marL="4752320" indent="0">
              <a:buNone/>
              <a:defRPr sz="207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8357" y="5260078"/>
            <a:ext cx="5026156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14681" y="3530053"/>
            <a:ext cx="5050909" cy="1730025"/>
          </a:xfrm>
        </p:spPr>
        <p:txBody>
          <a:bodyPr anchor="b"/>
          <a:lstStyle>
            <a:lvl1pPr marL="0" indent="0">
              <a:buNone/>
              <a:defRPr sz="3118" b="1"/>
            </a:lvl1pPr>
            <a:lvl2pPr marL="594040" indent="0">
              <a:buNone/>
              <a:defRPr sz="2599" b="1"/>
            </a:lvl2pPr>
            <a:lvl3pPr marL="1188080" indent="0">
              <a:buNone/>
              <a:defRPr sz="2339" b="1"/>
            </a:lvl3pPr>
            <a:lvl4pPr marL="1782120" indent="0">
              <a:buNone/>
              <a:defRPr sz="2079" b="1"/>
            </a:lvl4pPr>
            <a:lvl5pPr marL="2376160" indent="0">
              <a:buNone/>
              <a:defRPr sz="2079" b="1"/>
            </a:lvl5pPr>
            <a:lvl6pPr marL="2970200" indent="0">
              <a:buNone/>
              <a:defRPr sz="2079" b="1"/>
            </a:lvl6pPr>
            <a:lvl7pPr marL="3564240" indent="0">
              <a:buNone/>
              <a:defRPr sz="2079" b="1"/>
            </a:lvl7pPr>
            <a:lvl8pPr marL="4158280" indent="0">
              <a:buNone/>
              <a:defRPr sz="2079" b="1"/>
            </a:lvl8pPr>
            <a:lvl9pPr marL="4752320" indent="0">
              <a:buNone/>
              <a:defRPr sz="2079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14681" y="5260078"/>
            <a:ext cx="5050909" cy="773678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803B-2CA5-43A1-BEA5-E3B9601A04C9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EC7B-BEB6-4D84-9D7F-A8C5B8692D3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28338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803B-2CA5-43A1-BEA5-E3B9601A04C9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EC7B-BEB6-4D84-9D7F-A8C5B8692D3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5371610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803B-2CA5-43A1-BEA5-E3B9601A04C9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EC7B-BEB6-4D84-9D7F-A8C5B8692D3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200431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356" y="960014"/>
            <a:ext cx="3831883" cy="3360050"/>
          </a:xfrm>
        </p:spPr>
        <p:txBody>
          <a:bodyPr anchor="b"/>
          <a:lstStyle>
            <a:lvl1pPr>
              <a:defRPr sz="415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50909" y="2073367"/>
            <a:ext cx="6014680" cy="10233485"/>
          </a:xfrm>
        </p:spPr>
        <p:txBody>
          <a:bodyPr/>
          <a:lstStyle>
            <a:lvl1pPr>
              <a:defRPr sz="4158"/>
            </a:lvl1pPr>
            <a:lvl2pPr>
              <a:defRPr sz="3638"/>
            </a:lvl2pPr>
            <a:lvl3pPr>
              <a:defRPr sz="3118"/>
            </a:lvl3pPr>
            <a:lvl4pPr>
              <a:defRPr sz="2599"/>
            </a:lvl4pPr>
            <a:lvl5pPr>
              <a:defRPr sz="2599"/>
            </a:lvl5pPr>
            <a:lvl6pPr>
              <a:defRPr sz="2599"/>
            </a:lvl6pPr>
            <a:lvl7pPr>
              <a:defRPr sz="2599"/>
            </a:lvl7pPr>
            <a:lvl8pPr>
              <a:defRPr sz="2599"/>
            </a:lvl8pPr>
            <a:lvl9pPr>
              <a:defRPr sz="259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356" y="4320064"/>
            <a:ext cx="3831883" cy="8003453"/>
          </a:xfrm>
        </p:spPr>
        <p:txBody>
          <a:bodyPr/>
          <a:lstStyle>
            <a:lvl1pPr marL="0" indent="0">
              <a:buNone/>
              <a:defRPr sz="2079"/>
            </a:lvl1pPr>
            <a:lvl2pPr marL="594040" indent="0">
              <a:buNone/>
              <a:defRPr sz="1819"/>
            </a:lvl2pPr>
            <a:lvl3pPr marL="1188080" indent="0">
              <a:buNone/>
              <a:defRPr sz="1559"/>
            </a:lvl3pPr>
            <a:lvl4pPr marL="1782120" indent="0">
              <a:buNone/>
              <a:defRPr sz="1299"/>
            </a:lvl4pPr>
            <a:lvl5pPr marL="2376160" indent="0">
              <a:buNone/>
              <a:defRPr sz="1299"/>
            </a:lvl5pPr>
            <a:lvl6pPr marL="2970200" indent="0">
              <a:buNone/>
              <a:defRPr sz="1299"/>
            </a:lvl6pPr>
            <a:lvl7pPr marL="3564240" indent="0">
              <a:buNone/>
              <a:defRPr sz="1299"/>
            </a:lvl7pPr>
            <a:lvl8pPr marL="4158280" indent="0">
              <a:buNone/>
              <a:defRPr sz="1299"/>
            </a:lvl8pPr>
            <a:lvl9pPr marL="4752320" indent="0">
              <a:buNone/>
              <a:defRPr sz="129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803B-2CA5-43A1-BEA5-E3B9601A04C9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EC7B-BEB6-4D84-9D7F-A8C5B8692D3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301924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356" y="960014"/>
            <a:ext cx="3831883" cy="3360050"/>
          </a:xfrm>
        </p:spPr>
        <p:txBody>
          <a:bodyPr anchor="b"/>
          <a:lstStyle>
            <a:lvl1pPr>
              <a:defRPr sz="4158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050909" y="2073367"/>
            <a:ext cx="6014680" cy="10233485"/>
          </a:xfrm>
        </p:spPr>
        <p:txBody>
          <a:bodyPr anchor="t"/>
          <a:lstStyle>
            <a:lvl1pPr marL="0" indent="0">
              <a:buNone/>
              <a:defRPr sz="4158"/>
            </a:lvl1pPr>
            <a:lvl2pPr marL="594040" indent="0">
              <a:buNone/>
              <a:defRPr sz="3638"/>
            </a:lvl2pPr>
            <a:lvl3pPr marL="1188080" indent="0">
              <a:buNone/>
              <a:defRPr sz="3118"/>
            </a:lvl3pPr>
            <a:lvl4pPr marL="1782120" indent="0">
              <a:buNone/>
              <a:defRPr sz="2599"/>
            </a:lvl4pPr>
            <a:lvl5pPr marL="2376160" indent="0">
              <a:buNone/>
              <a:defRPr sz="2599"/>
            </a:lvl5pPr>
            <a:lvl6pPr marL="2970200" indent="0">
              <a:buNone/>
              <a:defRPr sz="2599"/>
            </a:lvl6pPr>
            <a:lvl7pPr marL="3564240" indent="0">
              <a:buNone/>
              <a:defRPr sz="2599"/>
            </a:lvl7pPr>
            <a:lvl8pPr marL="4158280" indent="0">
              <a:buNone/>
              <a:defRPr sz="2599"/>
            </a:lvl8pPr>
            <a:lvl9pPr marL="4752320" indent="0">
              <a:buNone/>
              <a:defRPr sz="25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356" y="4320064"/>
            <a:ext cx="3831883" cy="8003453"/>
          </a:xfrm>
        </p:spPr>
        <p:txBody>
          <a:bodyPr/>
          <a:lstStyle>
            <a:lvl1pPr marL="0" indent="0">
              <a:buNone/>
              <a:defRPr sz="2079"/>
            </a:lvl1pPr>
            <a:lvl2pPr marL="594040" indent="0">
              <a:buNone/>
              <a:defRPr sz="1819"/>
            </a:lvl2pPr>
            <a:lvl3pPr marL="1188080" indent="0">
              <a:buNone/>
              <a:defRPr sz="1559"/>
            </a:lvl3pPr>
            <a:lvl4pPr marL="1782120" indent="0">
              <a:buNone/>
              <a:defRPr sz="1299"/>
            </a:lvl4pPr>
            <a:lvl5pPr marL="2376160" indent="0">
              <a:buNone/>
              <a:defRPr sz="1299"/>
            </a:lvl5pPr>
            <a:lvl6pPr marL="2970200" indent="0">
              <a:buNone/>
              <a:defRPr sz="1299"/>
            </a:lvl6pPr>
            <a:lvl7pPr marL="3564240" indent="0">
              <a:buNone/>
              <a:defRPr sz="1299"/>
            </a:lvl7pPr>
            <a:lvl8pPr marL="4158280" indent="0">
              <a:buNone/>
              <a:defRPr sz="1299"/>
            </a:lvl8pPr>
            <a:lvl9pPr marL="4752320" indent="0">
              <a:buNone/>
              <a:defRPr sz="129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F4803B-2CA5-43A1-BEA5-E3B9601A04C9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20EC7B-BEB6-4D84-9D7F-A8C5B8692D3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52806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16809" y="766681"/>
            <a:ext cx="10247233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6809" y="3833390"/>
            <a:ext cx="10247233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6809" y="13346867"/>
            <a:ext cx="2673191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F4803B-2CA5-43A1-BEA5-E3B9601A04C9}" type="datetimeFigureOut">
              <a:rPr lang="en-IN" smtClean="0"/>
              <a:t>07-12-2021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5532" y="13346867"/>
            <a:ext cx="400978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90850" y="13346867"/>
            <a:ext cx="2673191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5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20EC7B-BEB6-4D84-9D7F-A8C5B8692D35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0397652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21" r:id="rId1"/>
    <p:sldLayoutId id="2147483722" r:id="rId2"/>
    <p:sldLayoutId id="2147483723" r:id="rId3"/>
    <p:sldLayoutId id="2147483724" r:id="rId4"/>
    <p:sldLayoutId id="2147483725" r:id="rId5"/>
    <p:sldLayoutId id="2147483726" r:id="rId6"/>
    <p:sldLayoutId id="2147483727" r:id="rId7"/>
    <p:sldLayoutId id="2147483728" r:id="rId8"/>
    <p:sldLayoutId id="2147483729" r:id="rId9"/>
    <p:sldLayoutId id="2147483730" r:id="rId10"/>
    <p:sldLayoutId id="2147483731" r:id="rId11"/>
  </p:sldLayoutIdLst>
  <p:txStyles>
    <p:titleStyle>
      <a:lvl1pPr algn="l" defTabSz="1188080" rtl="0" eaLnBrk="1" latinLnBrk="0" hangingPunct="1">
        <a:lnSpc>
          <a:spcPct val="90000"/>
        </a:lnSpc>
        <a:spcBef>
          <a:spcPct val="0"/>
        </a:spcBef>
        <a:buNone/>
        <a:defRPr sz="571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7020" indent="-297020" algn="l" defTabSz="1188080" rtl="0" eaLnBrk="1" latinLnBrk="0" hangingPunct="1">
        <a:lnSpc>
          <a:spcPct val="90000"/>
        </a:lnSpc>
        <a:spcBef>
          <a:spcPts val="1299"/>
        </a:spcBef>
        <a:buFont typeface="Arial" panose="020B0604020202020204" pitchFamily="34" charset="0"/>
        <a:buChar char="•"/>
        <a:defRPr sz="3638" kern="1200">
          <a:solidFill>
            <a:schemeClr val="tx1"/>
          </a:solidFill>
          <a:latin typeface="+mn-lt"/>
          <a:ea typeface="+mn-ea"/>
          <a:cs typeface="+mn-cs"/>
        </a:defRPr>
      </a:lvl1pPr>
      <a:lvl2pPr marL="891060" indent="-297020" algn="l" defTabSz="118808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3118" kern="1200">
          <a:solidFill>
            <a:schemeClr val="tx1"/>
          </a:solidFill>
          <a:latin typeface="+mn-lt"/>
          <a:ea typeface="+mn-ea"/>
          <a:cs typeface="+mn-cs"/>
        </a:defRPr>
      </a:lvl2pPr>
      <a:lvl3pPr marL="1485100" indent="-297020" algn="l" defTabSz="118808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599" kern="1200">
          <a:solidFill>
            <a:schemeClr val="tx1"/>
          </a:solidFill>
          <a:latin typeface="+mn-lt"/>
          <a:ea typeface="+mn-ea"/>
          <a:cs typeface="+mn-cs"/>
        </a:defRPr>
      </a:lvl3pPr>
      <a:lvl4pPr marL="2079140" indent="-297020" algn="l" defTabSz="118808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9" kern="1200">
          <a:solidFill>
            <a:schemeClr val="tx1"/>
          </a:solidFill>
          <a:latin typeface="+mn-lt"/>
          <a:ea typeface="+mn-ea"/>
          <a:cs typeface="+mn-cs"/>
        </a:defRPr>
      </a:lvl4pPr>
      <a:lvl5pPr marL="2673180" indent="-297020" algn="l" defTabSz="118808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9" kern="1200">
          <a:solidFill>
            <a:schemeClr val="tx1"/>
          </a:solidFill>
          <a:latin typeface="+mn-lt"/>
          <a:ea typeface="+mn-ea"/>
          <a:cs typeface="+mn-cs"/>
        </a:defRPr>
      </a:lvl5pPr>
      <a:lvl6pPr marL="3267220" indent="-297020" algn="l" defTabSz="118808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9" kern="1200">
          <a:solidFill>
            <a:schemeClr val="tx1"/>
          </a:solidFill>
          <a:latin typeface="+mn-lt"/>
          <a:ea typeface="+mn-ea"/>
          <a:cs typeface="+mn-cs"/>
        </a:defRPr>
      </a:lvl6pPr>
      <a:lvl7pPr marL="3861260" indent="-297020" algn="l" defTabSz="118808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9" kern="1200">
          <a:solidFill>
            <a:schemeClr val="tx1"/>
          </a:solidFill>
          <a:latin typeface="+mn-lt"/>
          <a:ea typeface="+mn-ea"/>
          <a:cs typeface="+mn-cs"/>
        </a:defRPr>
      </a:lvl7pPr>
      <a:lvl8pPr marL="4455300" indent="-297020" algn="l" defTabSz="118808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9" kern="1200">
          <a:solidFill>
            <a:schemeClr val="tx1"/>
          </a:solidFill>
          <a:latin typeface="+mn-lt"/>
          <a:ea typeface="+mn-ea"/>
          <a:cs typeface="+mn-cs"/>
        </a:defRPr>
      </a:lvl8pPr>
      <a:lvl9pPr marL="5049340" indent="-297020" algn="l" defTabSz="1188080" rtl="0" eaLnBrk="1" latinLnBrk="0" hangingPunct="1">
        <a:lnSpc>
          <a:spcPct val="90000"/>
        </a:lnSpc>
        <a:spcBef>
          <a:spcPts val="650"/>
        </a:spcBef>
        <a:buFont typeface="Arial" panose="020B0604020202020204" pitchFamily="34" charset="0"/>
        <a:buChar char="•"/>
        <a:defRPr sz="233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88080" rtl="0" eaLnBrk="1" latinLnBrk="0" hangingPunct="1">
        <a:defRPr sz="2339" kern="1200">
          <a:solidFill>
            <a:schemeClr val="tx1"/>
          </a:solidFill>
          <a:latin typeface="+mn-lt"/>
          <a:ea typeface="+mn-ea"/>
          <a:cs typeface="+mn-cs"/>
        </a:defRPr>
      </a:lvl1pPr>
      <a:lvl2pPr marL="594040" algn="l" defTabSz="1188080" rtl="0" eaLnBrk="1" latinLnBrk="0" hangingPunct="1">
        <a:defRPr sz="2339" kern="1200">
          <a:solidFill>
            <a:schemeClr val="tx1"/>
          </a:solidFill>
          <a:latin typeface="+mn-lt"/>
          <a:ea typeface="+mn-ea"/>
          <a:cs typeface="+mn-cs"/>
        </a:defRPr>
      </a:lvl2pPr>
      <a:lvl3pPr marL="1188080" algn="l" defTabSz="1188080" rtl="0" eaLnBrk="1" latinLnBrk="0" hangingPunct="1">
        <a:defRPr sz="2339" kern="1200">
          <a:solidFill>
            <a:schemeClr val="tx1"/>
          </a:solidFill>
          <a:latin typeface="+mn-lt"/>
          <a:ea typeface="+mn-ea"/>
          <a:cs typeface="+mn-cs"/>
        </a:defRPr>
      </a:lvl3pPr>
      <a:lvl4pPr marL="1782120" algn="l" defTabSz="1188080" rtl="0" eaLnBrk="1" latinLnBrk="0" hangingPunct="1">
        <a:defRPr sz="2339" kern="1200">
          <a:solidFill>
            <a:schemeClr val="tx1"/>
          </a:solidFill>
          <a:latin typeface="+mn-lt"/>
          <a:ea typeface="+mn-ea"/>
          <a:cs typeface="+mn-cs"/>
        </a:defRPr>
      </a:lvl4pPr>
      <a:lvl5pPr marL="2376160" algn="l" defTabSz="1188080" rtl="0" eaLnBrk="1" latinLnBrk="0" hangingPunct="1">
        <a:defRPr sz="2339" kern="1200">
          <a:solidFill>
            <a:schemeClr val="tx1"/>
          </a:solidFill>
          <a:latin typeface="+mn-lt"/>
          <a:ea typeface="+mn-ea"/>
          <a:cs typeface="+mn-cs"/>
        </a:defRPr>
      </a:lvl5pPr>
      <a:lvl6pPr marL="2970200" algn="l" defTabSz="1188080" rtl="0" eaLnBrk="1" latinLnBrk="0" hangingPunct="1">
        <a:defRPr sz="2339" kern="1200">
          <a:solidFill>
            <a:schemeClr val="tx1"/>
          </a:solidFill>
          <a:latin typeface="+mn-lt"/>
          <a:ea typeface="+mn-ea"/>
          <a:cs typeface="+mn-cs"/>
        </a:defRPr>
      </a:lvl6pPr>
      <a:lvl7pPr marL="3564240" algn="l" defTabSz="1188080" rtl="0" eaLnBrk="1" latinLnBrk="0" hangingPunct="1">
        <a:defRPr sz="2339" kern="1200">
          <a:solidFill>
            <a:schemeClr val="tx1"/>
          </a:solidFill>
          <a:latin typeface="+mn-lt"/>
          <a:ea typeface="+mn-ea"/>
          <a:cs typeface="+mn-cs"/>
        </a:defRPr>
      </a:lvl7pPr>
      <a:lvl8pPr marL="4158280" algn="l" defTabSz="1188080" rtl="0" eaLnBrk="1" latinLnBrk="0" hangingPunct="1">
        <a:defRPr sz="2339" kern="1200">
          <a:solidFill>
            <a:schemeClr val="tx1"/>
          </a:solidFill>
          <a:latin typeface="+mn-lt"/>
          <a:ea typeface="+mn-ea"/>
          <a:cs typeface="+mn-cs"/>
        </a:defRPr>
      </a:lvl8pPr>
      <a:lvl9pPr marL="4752320" algn="l" defTabSz="1188080" rtl="0" eaLnBrk="1" latinLnBrk="0" hangingPunct="1">
        <a:defRPr sz="233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hyperlink" Target="http://tcoffee.crg.cat/apps/tcoffee" TargetMode="Externa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71092367-8476-475D-96DA-1FDAC6430861}"/>
              </a:ext>
            </a:extLst>
          </p:cNvPr>
          <p:cNvSpPr txBox="1"/>
          <p:nvPr/>
        </p:nvSpPr>
        <p:spPr>
          <a:xfrm>
            <a:off x="508233" y="10242262"/>
            <a:ext cx="10474727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(a).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sequence of 3'UTR of MOAP1 and the respective binding positions for siRNA of MOAP1, hsa-miR-25-3p &amp; hsa-miR-1228-3p and hcmv-miR-UL70-3p were highlighted in different colors. 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.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figures generated through T-coffee alignment (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http://tcoffee.crg.cat/apps/tcoffee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showing the similarity score.  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.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mv-miR-UL70-3p and  hsa-miR-25-3p 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.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cmv-miR-UL70-3p  and hsa-miR-1228-3p; </a:t>
            </a:r>
            <a:r>
              <a:rPr lang="en-US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ii.  </a:t>
            </a:r>
            <a:r>
              <a:rPr lang="en-US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sa-miR-25-3p and hsa-miR-1228-3p. </a:t>
            </a:r>
            <a:endParaRPr lang="en-IN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FB926D4-B209-4055-A99B-984394BEF73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3357"/>
          <a:stretch/>
        </p:blipFill>
        <p:spPr>
          <a:xfrm>
            <a:off x="1249914" y="1150518"/>
            <a:ext cx="9381022" cy="564001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8328523-9CF1-4020-A677-F7514DBF2F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486603" y="7200106"/>
            <a:ext cx="3047156" cy="24905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A1D0A29-8242-4C6F-A797-ACEBF51EBE23}"/>
              </a:ext>
            </a:extLst>
          </p:cNvPr>
          <p:cNvSpPr txBox="1"/>
          <p:nvPr/>
        </p:nvSpPr>
        <p:spPr>
          <a:xfrm>
            <a:off x="2530577" y="9666451"/>
            <a:ext cx="402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IN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AF82BFF-B7DC-4636-AB56-90A8693270D5}"/>
              </a:ext>
            </a:extLst>
          </p:cNvPr>
          <p:cNvSpPr txBox="1"/>
          <p:nvPr/>
        </p:nvSpPr>
        <p:spPr>
          <a:xfrm>
            <a:off x="5666329" y="9661008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i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E4168B5B-37A4-4342-8698-9042D7591297}"/>
              </a:ext>
            </a:extLst>
          </p:cNvPr>
          <p:cNvSpPr txBox="1"/>
          <p:nvPr/>
        </p:nvSpPr>
        <p:spPr>
          <a:xfrm>
            <a:off x="8891850" y="9690680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iii)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2A986AE9-14ED-4F1C-AE98-2F22EE39A82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17521" y="7200106"/>
            <a:ext cx="3047156" cy="249057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3588A958-FB55-4100-B50A-A5E4560975F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352062" y="7202442"/>
            <a:ext cx="3047156" cy="248094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A38D2604-78BB-4EA2-BED8-B5E9E256664E}"/>
              </a:ext>
            </a:extLst>
          </p:cNvPr>
          <p:cNvSpPr txBox="1"/>
          <p:nvPr/>
        </p:nvSpPr>
        <p:spPr>
          <a:xfrm>
            <a:off x="493805" y="6873360"/>
            <a:ext cx="51167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2000" b="1" dirty="0">
                <a:latin typeface="Palatino Linotype" panose="02040502050505030304" pitchFamily="18" charset="0"/>
              </a:rPr>
              <a:t>(b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19326CB6-5408-4AE0-A44B-9BFB03959575}"/>
              </a:ext>
            </a:extLst>
          </p:cNvPr>
          <p:cNvSpPr txBox="1"/>
          <p:nvPr/>
        </p:nvSpPr>
        <p:spPr>
          <a:xfrm>
            <a:off x="152400" y="172903"/>
            <a:ext cx="135325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2000" b="1" dirty="0">
                <a:latin typeface="Palatino Linotype" panose="02040502050505030304" pitchFamily="18" charset="0"/>
              </a:rPr>
              <a:t>Figure S3: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A4B8FF0-B7F4-4AA2-8632-22C5FD147C94}"/>
              </a:ext>
            </a:extLst>
          </p:cNvPr>
          <p:cNvSpPr txBox="1"/>
          <p:nvPr/>
        </p:nvSpPr>
        <p:spPr>
          <a:xfrm>
            <a:off x="508233" y="711200"/>
            <a:ext cx="48282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2000" b="1" dirty="0">
                <a:latin typeface="Palatino Linotype" panose="02040502050505030304" pitchFamily="18" charset="0"/>
              </a:rPr>
              <a:t>(a)</a:t>
            </a:r>
          </a:p>
        </p:txBody>
      </p:sp>
    </p:spTree>
    <p:extLst>
      <p:ext uri="{BB962C8B-B14F-4D97-AF65-F5344CB8AC3E}">
        <p14:creationId xmlns:p14="http://schemas.microsoft.com/office/powerpoint/2010/main" val="100134003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64</TotalTime>
  <Words>95</Words>
  <Application>Microsoft Office PowerPoint</Application>
  <PresentationFormat>Custom</PresentationFormat>
  <Paragraphs>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hishek Pandeya</dc:creator>
  <cp:lastModifiedBy>Abhishek Pandeya</cp:lastModifiedBy>
  <cp:revision>85</cp:revision>
  <cp:lastPrinted>2021-12-06T21:32:43Z</cp:lastPrinted>
  <dcterms:created xsi:type="dcterms:W3CDTF">2021-06-20T07:56:08Z</dcterms:created>
  <dcterms:modified xsi:type="dcterms:W3CDTF">2021-12-06T21:32:46Z</dcterms:modified>
</cp:coreProperties>
</file>